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7F286-FE33-40A8-BD4C-412E142552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109B7B3-57FB-49BD-B0D5-88BED597CE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88E3CF-E8FB-44AE-9AB9-4D3AC3502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F37DBB-F80E-4739-AF2C-B3674884B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4114F0-B534-43CF-B8C6-4D0CFDFCA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9758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B758CA-C257-46B7-B897-B9AEC2077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C5B3982-7DA3-428E-B621-D414FB361C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85DA14-20DB-4E9E-9AF1-13063F68C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1809EF-00EE-4FF3-96B4-61A1CD953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AB152B-52A2-4714-A6A8-6FB5E90ED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892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C4A0686-2F8F-4A9F-B33F-C91365E37F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192820C-E123-44D3-B47F-4538EB273F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DC9833-9AFC-4DC2-940A-841899183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138297-E8C3-4FCF-B8A4-90E173880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2F7B27-D0DA-4CA8-83E5-B80EE19F7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115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18AF75-F4D4-4E03-B84C-0D00DB708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6705B5-1EFF-4BBE-8962-CA9A8D6957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37CA8C-3BAA-45E4-8A0C-2FE808F2C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B5F19F-22F1-4982-A39D-596CF35D8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B2A607-87A7-4B5B-AD8B-D805E2B42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201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1E84DC-150C-4484-B175-8266B3BD8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4CD59A-1A00-4BF0-8FCC-693751501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CC4AA6-4918-4D89-B1F1-9EC356623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5A3CCA-9D86-4E2B-9C64-3B4F1563A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2C1722-83BC-4D30-A1A6-F79CA1CBB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9235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6708EB-0674-460A-816A-29CB4219D1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E513AF-ED7B-419A-A775-D14D33E154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BD7067-A359-4591-BB84-866AB0201C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218353-27D0-4D57-8ACA-A2ED82AC2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AA7945-1434-4528-B7BD-81E342044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47991E-45A7-4F4C-9BFB-CE4EBC240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0411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98A1C7-766D-4430-A893-BC8C9C2283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C87268-BB17-4FCE-8AF3-79C201ECB0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6EFC05-7401-4BBB-88D7-E6F07E9336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30D65D2-20D9-4FA9-A023-C3A2ADA378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C94219A-E681-42F1-A8D7-7421B0F2E6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0093A73-CC12-4AF8-90A4-2D2DA0A39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5FECA22-D95E-4ADE-B8EE-BB31CE3BE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9133596-C868-4486-A254-002E26383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830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059439-B2CD-413B-AE2A-B210AD4BF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2A5510-B03A-474D-936B-1782FBC72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248103B-6065-45EB-9CA1-EC162C404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7496099-1E83-4999-8D30-1538C6FB5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784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49D44BF-F93C-45AF-AD07-EE328BB7E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C5721C3-5178-4F4B-830C-35F03000A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B0E9C0-ED4A-4A87-BAB1-409CF45FB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195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935C8F-3167-4937-8F86-707B1DC14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FE9974-919A-415C-8DDC-EC3BBAA587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DFD5CE-4269-45A7-B4A6-42AC35B552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010BE51-D030-4D2A-9586-D144DF9EF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F55DD5-63F8-40A0-99B9-4519CB105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D7044B-0A6F-4A95-90F8-2E0AD6172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897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406159-92F1-40DF-980D-0A0EE621E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C8180D8-5379-4D99-AF5D-E5F7099BE9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736325E-F795-4C97-8AC6-EAEA55E9FA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9C77E1-FD3B-4ED8-85F9-43C7D34B4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3D15C1-A433-43B9-96DE-85ACA0F62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D76DF8-F1EB-40D7-B8EF-45FCFAB7A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1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52407DB-43CA-437C-955E-C1B7A4BB7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E85570E-540F-494F-97F0-4DAC7126E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02B549-E94D-47B8-97E7-D7B550FEB0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A2E84-1308-478B-857A-3312A1F65FE6}" type="datetimeFigureOut">
              <a:rPr lang="zh-CN" altLang="en-US" smtClean="0"/>
              <a:t>2022/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F3651B-93E5-462B-B80F-C0278EC6BC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C25CFA-96A5-4B1A-84C0-55EAE95109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3B52E-4586-4A5D-B77D-91560F7A3D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351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AB2AB06-A099-4A8C-8878-BB9193DF4B5F}"/>
              </a:ext>
            </a:extLst>
          </p:cNvPr>
          <p:cNvSpPr txBox="1"/>
          <p:nvPr/>
        </p:nvSpPr>
        <p:spPr>
          <a:xfrm>
            <a:off x="137652" y="375144"/>
            <a:ext cx="12054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06442BD-205A-44B5-9655-5DEF6117B316}"/>
              </a:ext>
            </a:extLst>
          </p:cNvPr>
          <p:cNvSpPr txBox="1"/>
          <p:nvPr/>
        </p:nvSpPr>
        <p:spPr>
          <a:xfrm>
            <a:off x="273307" y="900078"/>
            <a:ext cx="6292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2157103-6B8B-40F5-AFE0-02F2E6D8468B}"/>
              </a:ext>
            </a:extLst>
          </p:cNvPr>
          <p:cNvSpPr txBox="1"/>
          <p:nvPr/>
        </p:nvSpPr>
        <p:spPr>
          <a:xfrm>
            <a:off x="6380828" y="930856"/>
            <a:ext cx="5106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F591F26-0D3F-49CD-934C-9809EFAFF3F0}"/>
              </a:ext>
            </a:extLst>
          </p:cNvPr>
          <p:cNvSpPr txBox="1"/>
          <p:nvPr/>
        </p:nvSpPr>
        <p:spPr>
          <a:xfrm>
            <a:off x="902572" y="5105974"/>
            <a:ext cx="10335699" cy="16619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zh-CN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ssociation of OH with OR of left ventricular hypertrophy by restricted cubic splines in CKD patients with stages 1 to 2 and 3 to 4. </a:t>
            </a:r>
            <a:r>
              <a:rPr lang="en-GB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estricted cubic splines were plotted using four default knots 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 the 20th, 40th, 60th, and 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80th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centiles</a:t>
            </a:r>
            <a:r>
              <a:rPr lang="en-GB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en-GB" altLang="zh-CN" sz="16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GB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dds ratios were adjusted for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ge, gender, diabetes, BMI, SBP, hemoglobin, serum albumin, and logarithmic transformation of urinary sodium and urinary protein</a:t>
            </a:r>
            <a:r>
              <a:rPr lang="en-US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sz="16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</a:t>
            </a:r>
            <a:r>
              <a:rPr lang="en-US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value for nonlinear association was 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</a:rPr>
              <a:t>0.0720 (A) in CKD patients with stages 1 to 2  and 0.3665 (B) in CKD patients with stages 3 to 4</a:t>
            </a:r>
            <a:r>
              <a:rPr lang="en-US" altLang="zh-CN" sz="16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OH overhydration; OR odds ratio; BMI body mass index; SBP systolic blood pressure</a:t>
            </a:r>
            <a: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endParaRPr lang="zh-CN" altLang="en-US" sz="16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2AAD673-B222-4FA5-BFFD-864AAEABF4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765" y="744476"/>
            <a:ext cx="4387183" cy="438718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4E2F410-E901-430C-9514-4ABE3B0A8C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1470" y="742018"/>
            <a:ext cx="4387183" cy="4387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6524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3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 lianqin</dc:creator>
  <cp:lastModifiedBy>Sandhya Patel</cp:lastModifiedBy>
  <cp:revision>11</cp:revision>
  <dcterms:created xsi:type="dcterms:W3CDTF">2021-12-06T06:55:10Z</dcterms:created>
  <dcterms:modified xsi:type="dcterms:W3CDTF">2022-01-26T17:49:25Z</dcterms:modified>
</cp:coreProperties>
</file>